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2.xml.rels" ContentType="application/vnd.openxmlformats-package.relationships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F6406E5-39C8-48F7-BA41-6B9EF10111A5}" type="slidenum">
              <a:rPr b="0" lang="en-GB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_rels/notesSlide2.xml.rels><?xml version="1.0" encoding="UTF-8"?>
<Relationships xmlns="http://schemas.openxmlformats.org/package/2006/relationships"><Relationship Id="rId1" Type="http://schemas.openxmlformats.org/officeDocument/2006/relationships/slide" Target="../slides/slide2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6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AD17BF5-C402-471A-B63F-2DAC9F2D15EE}" type="slidenum">
              <a:rPr b="0" lang="en-GB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5253EDC-A22A-4AA3-ABD1-AA06FB85C11E}" type="slidenum">
              <a:rPr b="0" lang="en-GB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129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0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B09E926-19CE-476C-954C-EFE5D437844D}" type="slidenum">
              <a:rPr b="0" lang="en-GB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E65B5C3-BA05-4D6B-A912-677D41F3E96F}" type="slidenum">
              <a:rPr b="0" lang="en-GB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133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87E9DC-FB40-4447-9E3F-9E558B8A996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10549E-95C1-4B49-862D-7DC31EE269E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993232-7A10-4125-A2BA-BB4BA2B4B8D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DF3B19-A359-4AC4-A90D-9E79A20373E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779728-F67B-485C-9106-E58B0235178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667983-BD8F-4A78-B188-9DC58F075D4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02751C-B03F-43AE-B2A9-B05AD5A743E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1028B5-73CD-4157-83D4-C8FFC342741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E03997-F8D5-46AF-B3C0-EB913345526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F568D5-A2B6-4557-98EF-46737B41156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DAB4D5-E8A1-4C4D-B525-F448D73FE8B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ED4C62-FE10-44C1-87BB-A461073D943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FF898E8-0712-42B7-AB1A-56B7CA4C9ED0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ext Box 4"/>
          <p:cNvSpPr/>
          <p:nvPr/>
        </p:nvSpPr>
        <p:spPr>
          <a:xfrm>
            <a:off x="2616120" y="1052640"/>
            <a:ext cx="3429000" cy="24624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Patient with enlarged lymph nodes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 Box 6"/>
          <p:cNvSpPr/>
          <p:nvPr/>
        </p:nvSpPr>
        <p:spPr>
          <a:xfrm>
            <a:off x="2544840" y="1766880"/>
            <a:ext cx="1714320" cy="24624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Patient referred for biopsy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 Box 54"/>
          <p:cNvSpPr/>
          <p:nvPr/>
        </p:nvSpPr>
        <p:spPr>
          <a:xfrm>
            <a:off x="3044880" y="4267080"/>
            <a:ext cx="13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No improvemen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51" name="Straight Arrow Connector 103"/>
          <p:cNvCxnSpPr/>
          <p:nvPr/>
        </p:nvCxnSpPr>
        <p:spPr>
          <a:xfrm flipH="1">
            <a:off x="4257000" y="2552400"/>
            <a:ext cx="3960" cy="85788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52" name="Straight Arrow Connector 128"/>
          <p:cNvCxnSpPr>
            <a:endCxn id="53" idx="0"/>
          </p:cNvCxnSpPr>
          <p:nvPr/>
        </p:nvCxnSpPr>
        <p:spPr>
          <a:xfrm>
            <a:off x="4259160" y="4195440"/>
            <a:ext cx="360" cy="38628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54" name="Text Box 6"/>
          <p:cNvSpPr/>
          <p:nvPr/>
        </p:nvSpPr>
        <p:spPr>
          <a:xfrm>
            <a:off x="3330720" y="3979800"/>
            <a:ext cx="1857240" cy="24624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Review after 4-8 week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Straight Connector 63"/>
          <p:cNvSpPr/>
          <p:nvPr/>
        </p:nvSpPr>
        <p:spPr>
          <a:xfrm>
            <a:off x="4330800" y="1306440"/>
            <a:ext cx="0" cy="1112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 Box 5"/>
          <p:cNvSpPr/>
          <p:nvPr/>
        </p:nvSpPr>
        <p:spPr>
          <a:xfrm>
            <a:off x="1616040" y="1338120"/>
            <a:ext cx="1857240" cy="3985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Lymph nodes are firm/hard and appear fixe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 Box 5"/>
          <p:cNvSpPr/>
          <p:nvPr/>
        </p:nvSpPr>
        <p:spPr>
          <a:xfrm>
            <a:off x="5330880" y="1338120"/>
            <a:ext cx="1714320" cy="3985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Lymph nodes are mobile, soft and fluctuan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58" name="Straight Arrow Connector 115"/>
          <p:cNvCxnSpPr>
            <a:endCxn id="49" idx="0"/>
          </p:cNvCxnSpPr>
          <p:nvPr/>
        </p:nvCxnSpPr>
        <p:spPr>
          <a:xfrm flipH="1">
            <a:off x="3402000" y="1411200"/>
            <a:ext cx="1800" cy="35604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59" name="Line 53"/>
          <p:cNvSpPr/>
          <p:nvPr/>
        </p:nvSpPr>
        <p:spPr>
          <a:xfrm>
            <a:off x="3402000" y="1409760"/>
            <a:ext cx="19288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Straight Connector 71"/>
          <p:cNvSpPr/>
          <p:nvPr/>
        </p:nvSpPr>
        <p:spPr>
          <a:xfrm>
            <a:off x="5330880" y="1409760"/>
            <a:ext cx="0" cy="7142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Text Box 5"/>
          <p:cNvSpPr/>
          <p:nvPr/>
        </p:nvSpPr>
        <p:spPr>
          <a:xfrm>
            <a:off x="2473200" y="2152800"/>
            <a:ext cx="1071720" cy="3985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Extra-inguinal sit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Straight Connector 89"/>
          <p:cNvSpPr/>
          <p:nvPr/>
        </p:nvSpPr>
        <p:spPr>
          <a:xfrm>
            <a:off x="3473280" y="2122560"/>
            <a:ext cx="0" cy="4284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Line 53"/>
          <p:cNvSpPr/>
          <p:nvPr/>
        </p:nvSpPr>
        <p:spPr>
          <a:xfrm>
            <a:off x="2687760" y="2550960"/>
            <a:ext cx="15714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Straight Connector 98"/>
          <p:cNvSpPr/>
          <p:nvPr/>
        </p:nvSpPr>
        <p:spPr>
          <a:xfrm>
            <a:off x="2687760" y="2550960"/>
            <a:ext cx="0" cy="4287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 Box 5"/>
          <p:cNvSpPr/>
          <p:nvPr/>
        </p:nvSpPr>
        <p:spPr>
          <a:xfrm>
            <a:off x="6045120" y="2163600"/>
            <a:ext cx="1071720" cy="246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Inguinal sit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66" name="Straight Arrow Connector 79"/>
          <p:cNvCxnSpPr/>
          <p:nvPr/>
        </p:nvCxnSpPr>
        <p:spPr>
          <a:xfrm flipH="1">
            <a:off x="6114240" y="2123640"/>
            <a:ext cx="3960" cy="42948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67" name="Text Box 6"/>
          <p:cNvSpPr/>
          <p:nvPr/>
        </p:nvSpPr>
        <p:spPr>
          <a:xfrm>
            <a:off x="5830920" y="2550960"/>
            <a:ext cx="1643040" cy="39852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Patient referred to OPD and STI clinic*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Text Box 54"/>
          <p:cNvSpPr/>
          <p:nvPr/>
        </p:nvSpPr>
        <p:spPr>
          <a:xfrm>
            <a:off x="1116000" y="2552760"/>
            <a:ext cx="164304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Signs and/or symptoms of active PT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Text Box 54"/>
          <p:cNvSpPr/>
          <p:nvPr/>
        </p:nvSpPr>
        <p:spPr>
          <a:xfrm>
            <a:off x="4187880" y="2550960"/>
            <a:ext cx="157140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No signs or symptoms of active PT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Line 53"/>
          <p:cNvSpPr/>
          <p:nvPr/>
        </p:nvSpPr>
        <p:spPr>
          <a:xfrm>
            <a:off x="3473280" y="2122560"/>
            <a:ext cx="26434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Text Box 4"/>
          <p:cNvSpPr/>
          <p:nvPr/>
        </p:nvSpPr>
        <p:spPr>
          <a:xfrm>
            <a:off x="1544760" y="2909880"/>
            <a:ext cx="2286000" cy="24624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Patient enters PTB algorithm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72" name="Straight Arrow Connector 119"/>
          <p:cNvCxnSpPr/>
          <p:nvPr/>
        </p:nvCxnSpPr>
        <p:spPr>
          <a:xfrm flipH="1">
            <a:off x="4258440" y="3622680"/>
            <a:ext cx="2520" cy="35784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73" name="Text Box 6"/>
          <p:cNvSpPr/>
          <p:nvPr/>
        </p:nvSpPr>
        <p:spPr>
          <a:xfrm>
            <a:off x="3330720" y="3408480"/>
            <a:ext cx="1857240" cy="39852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Treat with broad-spectrum antibiotics 3 week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74" name="Straight Arrow Connector 120"/>
          <p:cNvCxnSpPr/>
          <p:nvPr/>
        </p:nvCxnSpPr>
        <p:spPr>
          <a:xfrm>
            <a:off x="5187960" y="4122720"/>
            <a:ext cx="1286640" cy="216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75" name="Text Box 54"/>
          <p:cNvSpPr/>
          <p:nvPr/>
        </p:nvSpPr>
        <p:spPr>
          <a:xfrm>
            <a:off x="5187960" y="3908520"/>
            <a:ext cx="1285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Improvemen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Text Box 6"/>
          <p:cNvSpPr/>
          <p:nvPr/>
        </p:nvSpPr>
        <p:spPr>
          <a:xfrm>
            <a:off x="6473880" y="4019400"/>
            <a:ext cx="714240" cy="24624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No T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77" name="Straight Arrow Connector 141"/>
          <p:cNvCxnSpPr>
            <a:stCxn id="53" idx="3"/>
            <a:endCxn id="78" idx="1"/>
          </p:cNvCxnSpPr>
          <p:nvPr/>
        </p:nvCxnSpPr>
        <p:spPr>
          <a:xfrm>
            <a:off x="5187960" y="4780440"/>
            <a:ext cx="1072080" cy="36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79" name="Text Box 54"/>
          <p:cNvSpPr/>
          <p:nvPr/>
        </p:nvSpPr>
        <p:spPr>
          <a:xfrm>
            <a:off x="5116680" y="4552920"/>
            <a:ext cx="1285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Presen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Text Box 6"/>
          <p:cNvSpPr/>
          <p:nvPr/>
        </p:nvSpPr>
        <p:spPr>
          <a:xfrm>
            <a:off x="6259680" y="4581360"/>
            <a:ext cx="1214280" cy="39852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EPTB: initiate anti-TB treatmen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Text Box 54"/>
          <p:cNvSpPr/>
          <p:nvPr/>
        </p:nvSpPr>
        <p:spPr>
          <a:xfrm>
            <a:off x="3187800" y="5021280"/>
            <a:ext cx="13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Absen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81" name="Straight Arrow Connector 151"/>
          <p:cNvCxnSpPr/>
          <p:nvPr/>
        </p:nvCxnSpPr>
        <p:spPr>
          <a:xfrm flipH="1">
            <a:off x="4258440" y="4910040"/>
            <a:ext cx="1080" cy="38664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53" name="Text Box 5"/>
          <p:cNvSpPr/>
          <p:nvPr/>
        </p:nvSpPr>
        <p:spPr>
          <a:xfrm>
            <a:off x="3330720" y="4581360"/>
            <a:ext cx="1857240" cy="398520"/>
          </a:xfrm>
          <a:prstGeom prst="rect">
            <a:avLst/>
          </a:prstGeom>
          <a:solidFill>
            <a:srgbClr val="ffffff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Investigate for other sites of active T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Text Box 6"/>
          <p:cNvSpPr/>
          <p:nvPr/>
        </p:nvSpPr>
        <p:spPr>
          <a:xfrm>
            <a:off x="3473280" y="5295960"/>
            <a:ext cx="1571760" cy="398520"/>
          </a:xfrm>
          <a:prstGeom prst="rect">
            <a:avLst/>
          </a:prstGeom>
          <a:solidFill>
            <a:srgbClr val="bfbfbf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Suspected TBLN: patient referre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Text Box 43"/>
          <p:cNvSpPr/>
          <p:nvPr/>
        </p:nvSpPr>
        <p:spPr>
          <a:xfrm>
            <a:off x="755640" y="331920"/>
            <a:ext cx="7201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Arial"/>
              </a:rPr>
              <a:t>Supplementary Figure S1 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TextBox 1"/>
          <p:cNvSpPr/>
          <p:nvPr/>
        </p:nvSpPr>
        <p:spPr>
          <a:xfrm>
            <a:off x="3618000" y="5877000"/>
            <a:ext cx="4194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* OPD, Out Patient Department; STI, Sexually Transmitted Infect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5" name="TextBox 53"/>
          <p:cNvSpPr/>
          <p:nvPr/>
        </p:nvSpPr>
        <p:spPr>
          <a:xfrm>
            <a:off x="1187280" y="5599080"/>
            <a:ext cx="6602760" cy="91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Notes: 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AFB – Acid fast bacillus;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* persistent cough for 2 weeks, usually with expectoration; accompanied by one or more of the following: weight loss, chest pain, shortness of breath, intermittent fever, night sweats, loss of appetite, fatigue and malaise;     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** Suggestive findings include: upper lobe infiltrates (bilateral or unilateral right), cavitation (with thick wall &gt;2mm); patchy, nodular shadows around the cavity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Text Box 4"/>
          <p:cNvSpPr/>
          <p:nvPr/>
        </p:nvSpPr>
        <p:spPr>
          <a:xfrm>
            <a:off x="2421000" y="981000"/>
            <a:ext cx="3429000" cy="24624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Patient with symptoms suggestive of TB*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Text Box 54"/>
          <p:cNvSpPr/>
          <p:nvPr/>
        </p:nvSpPr>
        <p:spPr>
          <a:xfrm>
            <a:off x="1528920" y="1424160"/>
            <a:ext cx="1000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2 or 3x AFB 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Line 53"/>
          <p:cNvSpPr/>
          <p:nvPr/>
        </p:nvSpPr>
        <p:spPr>
          <a:xfrm>
            <a:off x="1563840" y="1622520"/>
            <a:ext cx="49291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Text Box 5"/>
          <p:cNvSpPr/>
          <p:nvPr/>
        </p:nvSpPr>
        <p:spPr>
          <a:xfrm>
            <a:off x="2492280" y="1447920"/>
            <a:ext cx="3286080" cy="246240"/>
          </a:xfrm>
          <a:prstGeom prst="rect">
            <a:avLst/>
          </a:prstGeom>
          <a:solidFill>
            <a:srgbClr val="ffffff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3x Sputum microscopy for AF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Text Box 54"/>
          <p:cNvSpPr/>
          <p:nvPr/>
        </p:nvSpPr>
        <p:spPr>
          <a:xfrm>
            <a:off x="5707080" y="1376280"/>
            <a:ext cx="928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3x AFB –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Text Box 54"/>
          <p:cNvSpPr/>
          <p:nvPr/>
        </p:nvSpPr>
        <p:spPr>
          <a:xfrm>
            <a:off x="3992400" y="1733400"/>
            <a:ext cx="1000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x AFB 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92" name="Straight Arrow Connector 64"/>
          <p:cNvCxnSpPr>
            <a:stCxn id="89" idx="2"/>
            <a:endCxn id="93" idx="0"/>
          </p:cNvCxnSpPr>
          <p:nvPr/>
        </p:nvCxnSpPr>
        <p:spPr>
          <a:xfrm>
            <a:off x="4134960" y="1704600"/>
            <a:ext cx="1080" cy="31500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94" name="Text Box 54"/>
          <p:cNvSpPr/>
          <p:nvPr/>
        </p:nvSpPr>
        <p:spPr>
          <a:xfrm>
            <a:off x="2124000" y="1979640"/>
            <a:ext cx="1000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 or 2x AFB 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Text Box 54"/>
          <p:cNvSpPr/>
          <p:nvPr/>
        </p:nvSpPr>
        <p:spPr>
          <a:xfrm>
            <a:off x="5064120" y="1979640"/>
            <a:ext cx="1000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2x AFB –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Line 53"/>
          <p:cNvSpPr/>
          <p:nvPr/>
        </p:nvSpPr>
        <p:spPr>
          <a:xfrm>
            <a:off x="2135160" y="2193840"/>
            <a:ext cx="37861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Text Box 6"/>
          <p:cNvSpPr/>
          <p:nvPr/>
        </p:nvSpPr>
        <p:spPr>
          <a:xfrm>
            <a:off x="3135240" y="2019240"/>
            <a:ext cx="2000160" cy="24624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2x additional sputum sample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97" name="Straight Arrow Connector 76"/>
          <p:cNvCxnSpPr/>
          <p:nvPr/>
        </p:nvCxnSpPr>
        <p:spPr>
          <a:xfrm flipH="1">
            <a:off x="5920560" y="2193840"/>
            <a:ext cx="2520" cy="21528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98" name="Straight Arrow Connector 77"/>
          <p:cNvCxnSpPr/>
          <p:nvPr/>
        </p:nvCxnSpPr>
        <p:spPr>
          <a:xfrm flipH="1">
            <a:off x="6490440" y="1622160"/>
            <a:ext cx="2520" cy="78660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99" name="Straight Arrow Connector 79"/>
          <p:cNvCxnSpPr>
            <a:endCxn id="100" idx="0"/>
          </p:cNvCxnSpPr>
          <p:nvPr/>
        </p:nvCxnSpPr>
        <p:spPr>
          <a:xfrm flipH="1">
            <a:off x="6206400" y="2836800"/>
            <a:ext cx="3960" cy="28656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101" name="Line 53"/>
          <p:cNvSpPr/>
          <p:nvPr/>
        </p:nvSpPr>
        <p:spPr>
          <a:xfrm flipV="1">
            <a:off x="4206960" y="3265560"/>
            <a:ext cx="164304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Text Box 54"/>
          <p:cNvSpPr/>
          <p:nvPr/>
        </p:nvSpPr>
        <p:spPr>
          <a:xfrm>
            <a:off x="4064040" y="3051000"/>
            <a:ext cx="13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No improvemen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103" name="Straight Arrow Connector 93"/>
          <p:cNvCxnSpPr/>
          <p:nvPr/>
        </p:nvCxnSpPr>
        <p:spPr>
          <a:xfrm flipH="1">
            <a:off x="6992640" y="3338280"/>
            <a:ext cx="2160" cy="147204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104" name="Text Box 54"/>
          <p:cNvSpPr/>
          <p:nvPr/>
        </p:nvSpPr>
        <p:spPr>
          <a:xfrm>
            <a:off x="5850000" y="3591000"/>
            <a:ext cx="13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Improvemen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105" name="Straight Arrow Connector 103"/>
          <p:cNvCxnSpPr/>
          <p:nvPr/>
        </p:nvCxnSpPr>
        <p:spPr>
          <a:xfrm>
            <a:off x="4205880" y="3265200"/>
            <a:ext cx="1080" cy="25452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106" name="Text Box 54"/>
          <p:cNvSpPr/>
          <p:nvPr/>
        </p:nvSpPr>
        <p:spPr>
          <a:xfrm>
            <a:off x="2319480" y="3489480"/>
            <a:ext cx="1000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 to 3x AFB 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Text Box 5"/>
          <p:cNvSpPr/>
          <p:nvPr/>
        </p:nvSpPr>
        <p:spPr>
          <a:xfrm>
            <a:off x="3278160" y="3519360"/>
            <a:ext cx="2000160" cy="246240"/>
          </a:xfrm>
          <a:prstGeom prst="rect">
            <a:avLst/>
          </a:prstGeom>
          <a:solidFill>
            <a:srgbClr val="ffffff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3x Sputum microscopy for AF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Text Box 54"/>
          <p:cNvSpPr/>
          <p:nvPr/>
        </p:nvSpPr>
        <p:spPr>
          <a:xfrm>
            <a:off x="4421160" y="3805200"/>
            <a:ext cx="928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3x AFB –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109" name="Straight Arrow Connector 115"/>
          <p:cNvCxnSpPr>
            <a:stCxn id="86" idx="2"/>
            <a:endCxn id="89" idx="0"/>
          </p:cNvCxnSpPr>
          <p:nvPr/>
        </p:nvCxnSpPr>
        <p:spPr>
          <a:xfrm>
            <a:off x="4134960" y="1234800"/>
            <a:ext cx="1080" cy="21348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110" name="Straight Arrow Connector 122"/>
          <p:cNvCxnSpPr>
            <a:endCxn id="111" idx="0"/>
          </p:cNvCxnSpPr>
          <p:nvPr/>
        </p:nvCxnSpPr>
        <p:spPr>
          <a:xfrm>
            <a:off x="4563000" y="3765600"/>
            <a:ext cx="1080" cy="35784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112" name="Straight Arrow Connector 128"/>
          <p:cNvCxnSpPr/>
          <p:nvPr/>
        </p:nvCxnSpPr>
        <p:spPr>
          <a:xfrm flipH="1">
            <a:off x="4206240" y="4265640"/>
            <a:ext cx="1080" cy="54504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113" name="Straight Arrow Connector 131"/>
          <p:cNvCxnSpPr/>
          <p:nvPr/>
        </p:nvCxnSpPr>
        <p:spPr>
          <a:xfrm flipH="1">
            <a:off x="4920480" y="4265640"/>
            <a:ext cx="1080" cy="54504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111" name="Text Box 5"/>
          <p:cNvSpPr/>
          <p:nvPr/>
        </p:nvSpPr>
        <p:spPr>
          <a:xfrm>
            <a:off x="3992400" y="4122720"/>
            <a:ext cx="1143000" cy="246240"/>
          </a:xfrm>
          <a:prstGeom prst="rect">
            <a:avLst/>
          </a:prstGeom>
          <a:solidFill>
            <a:srgbClr val="ffffff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hest x-ray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Text Box 54"/>
          <p:cNvSpPr/>
          <p:nvPr/>
        </p:nvSpPr>
        <p:spPr>
          <a:xfrm>
            <a:off x="4707000" y="4437000"/>
            <a:ext cx="135720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No suggestive finding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Text Box 54"/>
          <p:cNvSpPr/>
          <p:nvPr/>
        </p:nvSpPr>
        <p:spPr>
          <a:xfrm>
            <a:off x="3135240" y="4437000"/>
            <a:ext cx="135756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Suggestive findings**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Text Box 6"/>
          <p:cNvSpPr/>
          <p:nvPr/>
        </p:nvSpPr>
        <p:spPr>
          <a:xfrm>
            <a:off x="2992320" y="4809960"/>
            <a:ext cx="1500480" cy="39852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Smear-negative pulmonary T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Text Box 6"/>
          <p:cNvSpPr/>
          <p:nvPr/>
        </p:nvSpPr>
        <p:spPr>
          <a:xfrm>
            <a:off x="4635360" y="4809960"/>
            <a:ext cx="1785960" cy="55080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No TB: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treatment based on clinical signs and symptom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Text Box 6"/>
          <p:cNvSpPr/>
          <p:nvPr/>
        </p:nvSpPr>
        <p:spPr>
          <a:xfrm>
            <a:off x="6635880" y="4809960"/>
            <a:ext cx="714240" cy="24624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No T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Text Box 6"/>
          <p:cNvSpPr/>
          <p:nvPr/>
        </p:nvSpPr>
        <p:spPr>
          <a:xfrm>
            <a:off x="5278320" y="3122640"/>
            <a:ext cx="1857600" cy="24624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Review after 2-4 week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Text Box 6"/>
          <p:cNvSpPr/>
          <p:nvPr/>
        </p:nvSpPr>
        <p:spPr>
          <a:xfrm>
            <a:off x="4921200" y="2408400"/>
            <a:ext cx="2428920" cy="55080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Treat with non-specific broad-spectrum antibiotics (excl. anti-TB drugs and fluoroquinolones) for 7-10 day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120" name="Straight Arrow Connector 148"/>
          <p:cNvCxnSpPr/>
          <p:nvPr/>
        </p:nvCxnSpPr>
        <p:spPr>
          <a:xfrm flipH="1">
            <a:off x="1563480" y="1622520"/>
            <a:ext cx="2160" cy="318816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121" name="Straight Arrow Connector 155"/>
          <p:cNvCxnSpPr/>
          <p:nvPr/>
        </p:nvCxnSpPr>
        <p:spPr>
          <a:xfrm flipH="1">
            <a:off x="2134800" y="2193480"/>
            <a:ext cx="2160" cy="261684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122" name="Straight Arrow Connector 158"/>
          <p:cNvCxnSpPr/>
          <p:nvPr/>
        </p:nvCxnSpPr>
        <p:spPr>
          <a:xfrm flipH="1">
            <a:off x="2420640" y="3693960"/>
            <a:ext cx="2160" cy="111672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123" name="Line 53"/>
          <p:cNvSpPr/>
          <p:nvPr/>
        </p:nvSpPr>
        <p:spPr>
          <a:xfrm>
            <a:off x="2421000" y="3693960"/>
            <a:ext cx="8571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Text Box 6"/>
          <p:cNvSpPr/>
          <p:nvPr/>
        </p:nvSpPr>
        <p:spPr>
          <a:xfrm>
            <a:off x="1349280" y="4809960"/>
            <a:ext cx="1571760" cy="398520"/>
          </a:xfrm>
          <a:prstGeom prst="rect">
            <a:avLst/>
          </a:prstGeom>
          <a:solidFill>
            <a:srgbClr val="bfbfbf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Smear-positive pulmonary T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Text Box 85"/>
          <p:cNvSpPr/>
          <p:nvPr/>
        </p:nvSpPr>
        <p:spPr>
          <a:xfrm>
            <a:off x="468360" y="333360"/>
            <a:ext cx="7777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Arial"/>
              </a:rPr>
              <a:t>Supplementary Figure S1 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0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12-20T11:44:31Z</dcterms:created>
  <dc:creator>icomas</dc:creator>
  <dc:description/>
  <dc:language>en-US</dc:language>
  <cp:lastModifiedBy>Abraham Aseffa</cp:lastModifiedBy>
  <dcterms:modified xsi:type="dcterms:W3CDTF">2014-07-18T21:59:48Z</dcterms:modified>
  <cp:revision>47</cp:revision>
  <dc:subject/>
  <dc:title>Presentación de PowerPoint</dc:title>
</cp:coreProperties>
</file>